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22D3D-DA91-40E8-828F-ED6501967A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BFA53-F20E-4CA6-80C9-B21B2FEBFB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B20CA-56DA-4AC6-A32B-5CD7650C59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721B89-9C4F-4FD1-AF21-FC4F80A7BB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83F65-DCDA-4493-BBED-257F1001EA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983D8-DC64-4FFA-881F-A80665D526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A0AE7-07C3-4DE0-9D26-9EF92C1390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1C603-9B00-4CE1-AAB5-EAAA29D910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B6BEC-8B66-4CDD-A07F-520E08AB05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FDFE3-3F74-4DE6-9988-06A8C244BF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DFB5E4-8FE3-45A1-B1FF-1629BAFC06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69902-E939-454E-A086-BD59990E72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FF57EE-158A-4315-BB9E-44D4B48779C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97080" y="558720"/>
            <a:ext cx="99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 Rounded MT Bold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5299560" y="541440"/>
            <a:ext cx="115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 Rounded MT Bold"/>
              </a:rPr>
              <a:t>Takano et al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2624040" y="1392120"/>
            <a:ext cx="79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Ca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805200" y="1393920"/>
            <a:ext cx="790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V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 rot="5400000">
            <a:off x="2989440" y="954720"/>
            <a:ext cx="71280" cy="1584360"/>
          </a:xfrm>
          <a:custGeom>
            <a:avLst/>
            <a:gdLst>
              <a:gd name="textAreaLeft" fmla="*/ 45720 w 71280"/>
              <a:gd name="textAreaRight" fmla="*/ 71640 w 71280"/>
              <a:gd name="textAreaTop" fmla="*/ 41040 h 1584360"/>
              <a:gd name="textAreaBottom" fmla="*/ 1543320 h 1584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1865160" y="2577960"/>
            <a:ext cx="287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471680" y="243360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4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865160" y="2649600"/>
            <a:ext cx="287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471680" y="2549520"/>
            <a:ext cx="5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4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936720" y="2979720"/>
            <a:ext cx="1325520" cy="40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6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ERK leve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6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y Bio-plex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986120" y="3006720"/>
            <a:ext cx="93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1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2577960" y="300528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220920" y="300528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9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745080" y="3005280"/>
            <a:ext cx="93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479480" y="2995560"/>
            <a:ext cx="50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U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115280" y="183672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ple No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2180880" y="996840"/>
            <a:ext cx="226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estern blot analysi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247120" y="18525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9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829960" y="18525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453840" y="18525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1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036680" y="185256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2205000" y="2124000"/>
            <a:ext cx="2324160" cy="82404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902160" y="9032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4" name=""/>
          <p:cNvGrpSpPr/>
          <p:nvPr/>
        </p:nvGrpSpPr>
        <p:grpSpPr>
          <a:xfrm>
            <a:off x="1584360" y="3741840"/>
            <a:ext cx="2932200" cy="2448720"/>
            <a:chOff x="1584360" y="3741840"/>
            <a:chExt cx="2932200" cy="2448720"/>
          </a:xfrm>
        </p:grpSpPr>
        <p:sp>
          <p:nvSpPr>
            <p:cNvPr id="65" name=""/>
            <p:cNvSpPr/>
            <p:nvPr/>
          </p:nvSpPr>
          <p:spPr>
            <a:xfrm>
              <a:off x="4514760" y="5846760"/>
              <a:ext cx="360" cy="9360"/>
            </a:xfrm>
            <a:custGeom>
              <a:avLst/>
              <a:gdLst/>
              <a:ahLst/>
              <a:rect l="l" t="t" r="r" b="b"/>
              <a:pathLst>
                <a:path w="0" h="8">
                  <a:moveTo>
                    <a:pt x="0" y="0"/>
                  </a:moveTo>
                  <a:lnTo>
                    <a:pt x="0" y="6"/>
                  </a:lnTo>
                  <a:lnTo>
                    <a:pt x="0" y="8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514760" y="5875200"/>
              <a:ext cx="360" cy="9720"/>
            </a:xfrm>
            <a:custGeom>
              <a:avLst/>
              <a:gdLst/>
              <a:ahLst/>
              <a:rect l="l" t="t" r="r" b="b"/>
              <a:pathLst>
                <a:path w="0" h="9">
                  <a:moveTo>
                    <a:pt x="0" y="0"/>
                  </a:moveTo>
                  <a:lnTo>
                    <a:pt x="0" y="6"/>
                  </a:lnTo>
                  <a:lnTo>
                    <a:pt x="0" y="9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178000" y="5881680"/>
              <a:ext cx="41400" cy="360"/>
            </a:xfrm>
            <a:custGeom>
              <a:avLst/>
              <a:gdLst/>
              <a:ahLst/>
              <a:rect l="l" t="t" r="r" b="b"/>
              <a:pathLst>
                <a:path w="41" h="0">
                  <a:moveTo>
                    <a:pt x="0" y="0"/>
                  </a:moveTo>
                  <a:lnTo>
                    <a:pt x="39" y="0"/>
                  </a:lnTo>
                  <a:lnTo>
                    <a:pt x="41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178000" y="5540400"/>
              <a:ext cx="41400" cy="360"/>
            </a:xfrm>
            <a:custGeom>
              <a:avLst/>
              <a:gdLst/>
              <a:ahLst/>
              <a:rect l="l" t="t" r="r" b="b"/>
              <a:pathLst>
                <a:path w="41" h="0">
                  <a:moveTo>
                    <a:pt x="0" y="0"/>
                  </a:moveTo>
                  <a:lnTo>
                    <a:pt x="39" y="0"/>
                  </a:lnTo>
                  <a:lnTo>
                    <a:pt x="41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178000" y="5199120"/>
              <a:ext cx="41400" cy="360"/>
            </a:xfrm>
            <a:custGeom>
              <a:avLst/>
              <a:gdLst/>
              <a:ahLst/>
              <a:rect l="l" t="t" r="r" b="b"/>
              <a:pathLst>
                <a:path w="41" h="0">
                  <a:moveTo>
                    <a:pt x="0" y="0"/>
                  </a:moveTo>
                  <a:lnTo>
                    <a:pt x="39" y="0"/>
                  </a:lnTo>
                  <a:lnTo>
                    <a:pt x="41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178000" y="4857840"/>
              <a:ext cx="41400" cy="360"/>
            </a:xfrm>
            <a:custGeom>
              <a:avLst/>
              <a:gdLst/>
              <a:ahLst/>
              <a:rect l="l" t="t" r="r" b="b"/>
              <a:pathLst>
                <a:path w="41" h="0">
                  <a:moveTo>
                    <a:pt x="0" y="0"/>
                  </a:moveTo>
                  <a:lnTo>
                    <a:pt x="39" y="0"/>
                  </a:lnTo>
                  <a:lnTo>
                    <a:pt x="41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178000" y="4519440"/>
              <a:ext cx="41400" cy="360"/>
            </a:xfrm>
            <a:custGeom>
              <a:avLst/>
              <a:gdLst/>
              <a:ahLst/>
              <a:rect l="l" t="t" r="r" b="b"/>
              <a:pathLst>
                <a:path w="41" h="0">
                  <a:moveTo>
                    <a:pt x="0" y="0"/>
                  </a:moveTo>
                  <a:lnTo>
                    <a:pt x="39" y="0"/>
                  </a:lnTo>
                  <a:lnTo>
                    <a:pt x="41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178000" y="4178160"/>
              <a:ext cx="41400" cy="360"/>
            </a:xfrm>
            <a:custGeom>
              <a:avLst/>
              <a:gdLst/>
              <a:ahLst/>
              <a:rect l="l" t="t" r="r" b="b"/>
              <a:pathLst>
                <a:path w="41" h="0">
                  <a:moveTo>
                    <a:pt x="0" y="0"/>
                  </a:moveTo>
                  <a:lnTo>
                    <a:pt x="39" y="0"/>
                  </a:lnTo>
                  <a:lnTo>
                    <a:pt x="41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178000" y="3836880"/>
              <a:ext cx="41400" cy="360"/>
            </a:xfrm>
            <a:custGeom>
              <a:avLst/>
              <a:gdLst/>
              <a:ahLst/>
              <a:rect l="l" t="t" r="r" b="b"/>
              <a:pathLst>
                <a:path w="41" h="0">
                  <a:moveTo>
                    <a:pt x="0" y="0"/>
                  </a:moveTo>
                  <a:lnTo>
                    <a:pt x="39" y="0"/>
                  </a:lnTo>
                  <a:lnTo>
                    <a:pt x="41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471920" y="5881680"/>
              <a:ext cx="42840" cy="360"/>
            </a:xfrm>
            <a:custGeom>
              <a:avLst/>
              <a:gdLst/>
              <a:ahLst/>
              <a:rect l="l" t="t" r="r" b="b"/>
              <a:pathLst>
                <a:path w="44" h="0">
                  <a:moveTo>
                    <a:pt x="44" y="0"/>
                  </a:moveTo>
                  <a:lnTo>
                    <a:pt x="2" y="0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178000" y="5838840"/>
              <a:ext cx="360" cy="42840"/>
            </a:xfrm>
            <a:custGeom>
              <a:avLst/>
              <a:gdLst/>
              <a:ahLst/>
              <a:rect l="l" t="t" r="r" b="b"/>
              <a:pathLst>
                <a:path w="0" h="41">
                  <a:moveTo>
                    <a:pt x="0" y="41"/>
                  </a:move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346560" y="5838840"/>
              <a:ext cx="360" cy="42840"/>
            </a:xfrm>
            <a:custGeom>
              <a:avLst/>
              <a:gdLst/>
              <a:ahLst/>
              <a:rect l="l" t="t" r="r" b="b"/>
              <a:pathLst>
                <a:path w="0" h="41">
                  <a:moveTo>
                    <a:pt x="0" y="41"/>
                  </a:move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514760" y="5838840"/>
              <a:ext cx="360" cy="42840"/>
            </a:xfrm>
            <a:custGeom>
              <a:avLst/>
              <a:gdLst/>
              <a:ahLst/>
              <a:rect l="l" t="t" r="r" b="b"/>
              <a:pathLst>
                <a:path w="0" h="41">
                  <a:moveTo>
                    <a:pt x="0" y="41"/>
                  </a:move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178000" y="3836880"/>
              <a:ext cx="360" cy="42840"/>
            </a:xfrm>
            <a:custGeom>
              <a:avLst/>
              <a:gdLst/>
              <a:ahLst/>
              <a:rect l="l" t="t" r="r" b="b"/>
              <a:pathLst>
                <a:path w="0" h="41">
                  <a:moveTo>
                    <a:pt x="0" y="0"/>
                  </a:moveTo>
                  <a:lnTo>
                    <a:pt x="0" y="39"/>
                  </a:lnTo>
                  <a:lnTo>
                    <a:pt x="0" y="41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178000" y="3833640"/>
              <a:ext cx="360" cy="2048040"/>
            </a:xfrm>
            <a:custGeom>
              <a:avLst/>
              <a:gdLst/>
              <a:ahLst/>
              <a:rect l="l" t="t" r="r" b="b"/>
              <a:pathLst>
                <a:path w="0" h="1990">
                  <a:moveTo>
                    <a:pt x="0" y="1990"/>
                  </a:moveTo>
                  <a:lnTo>
                    <a:pt x="0" y="3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178000" y="5881680"/>
              <a:ext cx="2338560" cy="360"/>
            </a:xfrm>
            <a:custGeom>
              <a:avLst/>
              <a:gdLst/>
              <a:ahLst/>
              <a:rect l="l" t="t" r="r" b="b"/>
              <a:pathLst>
                <a:path w="2408" h="0">
                  <a:moveTo>
                    <a:pt x="0" y="0"/>
                  </a:moveTo>
                  <a:lnTo>
                    <a:pt x="2406" y="0"/>
                  </a:lnTo>
                  <a:lnTo>
                    <a:pt x="2408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743200" y="5175360"/>
              <a:ext cx="38160" cy="41040"/>
            </a:xfrm>
            <a:prstGeom prst="ellipse">
              <a:avLst/>
            </a:prstGeom>
            <a:noFill/>
            <a:ln w="3240">
              <a:solidFill>
                <a:srgbClr val="ff070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743200" y="4383000"/>
              <a:ext cx="38160" cy="39600"/>
            </a:xfrm>
            <a:prstGeom prst="ellipse">
              <a:avLst/>
            </a:prstGeom>
            <a:noFill/>
            <a:ln w="3240">
              <a:solidFill>
                <a:srgbClr val="ff070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743200" y="4095720"/>
              <a:ext cx="38160" cy="39600"/>
            </a:xfrm>
            <a:prstGeom prst="ellipse">
              <a:avLst/>
            </a:prstGeom>
            <a:noFill/>
            <a:ln w="3240">
              <a:solidFill>
                <a:srgbClr val="ff070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911760" y="5064120"/>
              <a:ext cx="360" cy="39600"/>
            </a:xfrm>
            <a:custGeom>
              <a:avLst/>
              <a:gdLst/>
              <a:ahLst/>
              <a:rect l="l" t="t" r="r" b="b"/>
              <a:pathLst>
                <a:path w="0" h="39">
                  <a:moveTo>
                    <a:pt x="0" y="0"/>
                  </a:moveTo>
                  <a:lnTo>
                    <a:pt x="0" y="37"/>
                  </a:lnTo>
                  <a:lnTo>
                    <a:pt x="0" y="39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911760" y="5102280"/>
              <a:ext cx="39600" cy="360"/>
            </a:xfrm>
            <a:custGeom>
              <a:avLst/>
              <a:gdLst/>
              <a:ahLst/>
              <a:rect l="l" t="t" r="r" b="b"/>
              <a:pathLst>
                <a:path w="40" h="0">
                  <a:moveTo>
                    <a:pt x="0" y="0"/>
                  </a:moveTo>
                  <a:lnTo>
                    <a:pt x="38" y="0"/>
                  </a:lnTo>
                  <a:lnTo>
                    <a:pt x="4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948120" y="5062680"/>
              <a:ext cx="360" cy="39600"/>
            </a:xfrm>
            <a:custGeom>
              <a:avLst/>
              <a:gdLst/>
              <a:ahLst/>
              <a:rect l="l" t="t" r="r" b="b"/>
              <a:pathLst>
                <a:path w="0" h="39">
                  <a:moveTo>
                    <a:pt x="0" y="39"/>
                  </a:move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909960" y="5064120"/>
              <a:ext cx="38160" cy="360"/>
            </a:xfrm>
            <a:custGeom>
              <a:avLst/>
              <a:gdLst/>
              <a:ahLst/>
              <a:rect l="l" t="t" r="r" b="b"/>
              <a:pathLst>
                <a:path w="40" h="0">
                  <a:moveTo>
                    <a:pt x="40" y="0"/>
                  </a:moveTo>
                  <a:lnTo>
                    <a:pt x="2" y="0"/>
                  </a:ln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990080" y="57895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990080" y="54450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990080" y="51037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ゴシック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990080" y="47610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990080" y="44226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990080" y="40813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990080" y="37418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512440" y="5977080"/>
              <a:ext cx="445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aCa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819600" y="5975280"/>
              <a:ext cx="247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V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1106280" y="4611960"/>
              <a:ext cx="1232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and intensity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8" name=""/>
          <p:cNvSpPr/>
          <p:nvPr/>
        </p:nvSpPr>
        <p:spPr>
          <a:xfrm>
            <a:off x="901800" y="35845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高野 重紹</cp:lastModifiedBy>
  <cp:lastPrinted>2009-01-13T05:13:19Z</cp:lastPrinted>
  <dcterms:modified xsi:type="dcterms:W3CDTF">2010-05-03T04:47:43Z</dcterms:modified>
  <cp:revision>247</cp:revision>
  <dc:subject/>
  <dc:title>PowerPoint プレゼンテーション</dc:title>
</cp:coreProperties>
</file>